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0BB8B-9F8D-47BF-8361-5A2A479EB2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AAE69-1593-4D55-AF38-2AD03F3E74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A503B-4E72-4958-9418-0F4E11FFCA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96C114-0373-421A-8A42-C40D59C29E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8DB43-B7AC-4DCE-B60C-41CEE71B00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D854F-3356-47A7-8343-AA89A79750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EB47F-B73F-43F1-BB77-5DEBA897ED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371AB9-7508-4DF2-938C-F6AB92B20B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13C621-4A3F-4A7F-8629-57DF5F3E5F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6C9E5-BEF8-4439-A9CC-C695BC6278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26464-3F28-4619-A8CF-D29066759E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3591B-60C4-440F-8C35-576CDB2A09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3D0924-AB6F-4A3F-9898-4CA3A636DA8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3"/>
          <p:cNvGrpSpPr/>
          <p:nvPr/>
        </p:nvGrpSpPr>
        <p:grpSpPr>
          <a:xfrm>
            <a:off x="457200" y="762120"/>
            <a:ext cx="6172200" cy="3441960"/>
            <a:chOff x="457200" y="762120"/>
            <a:chExt cx="6172200" cy="3441960"/>
          </a:xfrm>
        </p:grpSpPr>
        <p:sp>
          <p:nvSpPr>
            <p:cNvPr id="42" name="TextBox 3"/>
            <p:cNvSpPr/>
            <p:nvPr/>
          </p:nvSpPr>
          <p:spPr>
            <a:xfrm>
              <a:off x="457200" y="762120"/>
              <a:ext cx="6172200" cy="344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HN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1  --MASSMRS--LFSDHGK</a:t>
              </a: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Y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VES</a:t>
              </a: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F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RRFLNHST</a:t>
              </a:r>
              <a:r>
                <a:rPr b="0" lang="en-US" sz="1100" spc="-1" strike="noStrike">
                  <a:solidFill>
                    <a:srgbClr val="008000"/>
                  </a:solidFill>
                  <a:latin typeface="Courier New"/>
                </a:rPr>
                <a:t>E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HQCMQEFMDKKLPGIIGRIGDTKSEIKI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PfP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1  MTLIENLNSDKTFLENNQ</a:t>
              </a: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Y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TDE</a:t>
              </a: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G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VKVYEFIF</a:t>
              </a:r>
              <a:r>
                <a:rPr b="0" lang="en-US" sz="1100" spc="-1" strike="noStrike">
                  <a:solidFill>
                    <a:srgbClr val="008000"/>
                  </a:solidFill>
                  <a:latin typeface="Courier New"/>
                </a:rPr>
                <a:t>G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ENYISSGGLEATKKILSDI-ELNENSKV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: ..:.*   * ::.:*.:.  :. :.   .: :..   :    *:. * : :.: *: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HN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57  LSIGGGAG</a:t>
              </a:r>
              <a:r>
                <a:rPr b="0" lang="en-US" sz="1100" spc="-1" strike="noStrike">
                  <a:solidFill>
                    <a:srgbClr val="008000"/>
                  </a:solidFill>
                  <a:latin typeface="Courier New"/>
                </a:rPr>
                <a:t>E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IDLQILSKVQAQYPGVCINNEVVEPSAEQIAKYKELVAKTSNLENVKFAW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PfP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60  LDIGSGLG</a:t>
              </a:r>
              <a:r>
                <a:rPr b="0" lang="en-US" sz="1100" spc="-1" strike="noStrike">
                  <a:solidFill>
                    <a:srgbClr val="008000"/>
                  </a:solidFill>
                  <a:latin typeface="Courier New"/>
                </a:rPr>
                <a:t>G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GCMYINEKYGAHTHGIDICSNIVNMANERVSGNNKIIFEANDILTKEFP-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        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*.**.* *   : * .*  *:  *: * .::*: : *:::  :::: ::.:: . :*.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HN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117 KETSSEYQSRMLEKKELQKWDFIHMIQMLYYVKDIPATLKFFHSLLGTNAKMLIIVVSGS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PfP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118 -EN--------------N-FDLIYSRDAILHLSLENKNKLFQKCYKWLKPTGTLLITDYC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*.              : :*:*:  : : ::.    .  * :.    :..  :::.. .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HN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177 SGWDKL</a:t>
              </a: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W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KKYGSR</a:t>
              </a:r>
              <a:r>
                <a:rPr b="0" lang="en-US" sz="1100" spc="-1" strike="noStrike">
                  <a:solidFill>
                    <a:srgbClr val="ff8000"/>
                  </a:solidFill>
                  <a:latin typeface="Courier New"/>
                </a:rPr>
                <a:t>F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PQDDLCQ</a:t>
              </a: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Y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ITSDDLTQMLDNLGLKYECYDLLSTMDISDCFIDGNE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PfP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162 ATEKEN</a:t>
              </a: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W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DDEFKE</a:t>
              </a:r>
              <a:r>
                <a:rPr b="0" lang="en-US" sz="1100" spc="-1" strike="noStrike">
                  <a:solidFill>
                    <a:srgbClr val="ff8000"/>
                  </a:solidFill>
                  <a:latin typeface="Courier New"/>
                </a:rPr>
                <a:t>Y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VKQRKYT</a:t>
              </a: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L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ITVEEYADILTACNFKNVVSKDLSDYWNQLLEVEHKY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        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:  .: *..  ..: ::     ** :: :::*   .:*    . **    .   :: :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HN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237 GDLLWD</a:t>
              </a: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F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LTETCNFNATAPPDLRAELGKDLQEPEFSAKKEGKVLFNNTLSFIVIE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PfPMT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222 HENKEE</a:t>
              </a: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F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LKL---FSEKKFISLDDGWSRKIKDSKRKMQRWG--YFKATKN-----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            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</a:rPr>
                <a:t>:   :**.    *. .   .*    .:.:::.: . :: *   *: * .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5"/>
            <p:cNvSpPr/>
            <p:nvPr/>
          </p:nvSpPr>
          <p:spPr>
            <a:xfrm>
              <a:off x="2757600" y="812880"/>
              <a:ext cx="34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1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5"/>
            <p:cNvSpPr/>
            <p:nvPr/>
          </p:nvSpPr>
          <p:spPr>
            <a:xfrm>
              <a:off x="3094200" y="812880"/>
              <a:ext cx="34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1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5"/>
            <p:cNvSpPr/>
            <p:nvPr/>
          </p:nvSpPr>
          <p:spPr>
            <a:xfrm>
              <a:off x="3849840" y="812880"/>
              <a:ext cx="34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8000"/>
                  </a:solidFill>
                  <a:latin typeface="Courier New"/>
                </a:rPr>
                <a:t>2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6"/>
            <p:cNvSpPr/>
            <p:nvPr/>
          </p:nvSpPr>
          <p:spPr>
            <a:xfrm>
              <a:off x="2008440" y="1485720"/>
              <a:ext cx="34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8000"/>
                  </a:solidFill>
                  <a:latin typeface="Courier New"/>
                </a:rPr>
                <a:t>6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7"/>
            <p:cNvSpPr/>
            <p:nvPr/>
          </p:nvSpPr>
          <p:spPr>
            <a:xfrm>
              <a:off x="1798200" y="2819520"/>
              <a:ext cx="43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18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8"/>
            <p:cNvSpPr/>
            <p:nvPr/>
          </p:nvSpPr>
          <p:spPr>
            <a:xfrm>
              <a:off x="2401200" y="2819520"/>
              <a:ext cx="43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8000"/>
                  </a:solidFill>
                  <a:latin typeface="Courier New"/>
                </a:rPr>
                <a:t>19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9"/>
            <p:cNvSpPr/>
            <p:nvPr/>
          </p:nvSpPr>
          <p:spPr>
            <a:xfrm>
              <a:off x="3049200" y="2819520"/>
              <a:ext cx="43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ourier New"/>
                </a:rPr>
                <a:t>19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0"/>
            <p:cNvSpPr/>
            <p:nvPr/>
          </p:nvSpPr>
          <p:spPr>
            <a:xfrm>
              <a:off x="1791720" y="3486240"/>
              <a:ext cx="43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</a:rPr>
                <a:t>24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07T18:32:12Z</dcterms:created>
  <dc:creator>UCHC</dc:creator>
  <dc:description/>
  <dc:language>en-US</dc:language>
  <cp:lastModifiedBy>James McSweeney</cp:lastModifiedBy>
  <cp:lastPrinted>2008-12-15T19:04:20Z</cp:lastPrinted>
  <dcterms:modified xsi:type="dcterms:W3CDTF">2010-01-29T11:27:08Z</dcterms:modified>
  <cp:revision>154</cp:revision>
  <dc:subject/>
  <dc:title>PowerPoint Presentation</dc:title>
</cp:coreProperties>
</file>